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2" r:id="rId3"/>
    <p:sldId id="260" r:id="rId4"/>
    <p:sldId id="263" r:id="rId5"/>
    <p:sldId id="258" r:id="rId6"/>
    <p:sldId id="261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8787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835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0308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4817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581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378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63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232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897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115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7878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13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3D22D5-812B-4339-896F-F5E5E670C2B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BD6299-C35C-4BD1-9B16-28A080AE84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04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3563" b="5868"/>
          <a:stretch/>
        </p:blipFill>
        <p:spPr>
          <a:xfrm>
            <a:off x="2880000" y="972000"/>
            <a:ext cx="7129026" cy="4680932"/>
          </a:xfrm>
          <a:prstGeom prst="rect">
            <a:avLst/>
          </a:prstGeom>
        </p:spPr>
      </p:pic>
      <p:graphicFrame>
        <p:nvGraphicFramePr>
          <p:cNvPr id="5" name="表 5">
            <a:extLst>
              <a:ext uri="{FF2B5EF4-FFF2-40B4-BE49-F238E27FC236}">
                <a16:creationId xmlns:a16="http://schemas.microsoft.com/office/drawing/2014/main" id="{878984C6-746A-4563-9F20-9EF4799AFB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8620166"/>
              </p:ext>
            </p:extLst>
          </p:nvPr>
        </p:nvGraphicFramePr>
        <p:xfrm>
          <a:off x="5657850" y="364691"/>
          <a:ext cx="4966131" cy="1432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46907">
                  <a:extLst>
                    <a:ext uri="{9D8B030D-6E8A-4147-A177-3AD203B41FA5}">
                      <a16:colId xmlns:a16="http://schemas.microsoft.com/office/drawing/2014/main" val="2181377161"/>
                    </a:ext>
                  </a:extLst>
                </a:gridCol>
                <a:gridCol w="3119224">
                  <a:extLst>
                    <a:ext uri="{9D8B030D-6E8A-4147-A177-3AD203B41FA5}">
                      <a16:colId xmlns:a16="http://schemas.microsoft.com/office/drawing/2014/main" val="3139930827"/>
                    </a:ext>
                  </a:extLst>
                </a:gridCol>
              </a:tblGrid>
              <a:tr h="277714">
                <a:tc gridSpan="2"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        </a:t>
                      </a:r>
                      <a:r>
                        <a:rPr kumimoji="1" lang="en-US" altLang="ja-JP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verall survival time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9936045"/>
                  </a:ext>
                </a:extLst>
              </a:tr>
              <a:tr h="277714"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ESAT-6 high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9 days (95% CI: 862–NA)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4604076"/>
                  </a:ext>
                </a:extLst>
              </a:tr>
              <a:tr h="277714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ESAT-6 low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6 days (95% CI: 141–529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2510744"/>
                  </a:ext>
                </a:extLst>
              </a:tr>
              <a:tr h="462857">
                <a:tc gridSpan="2"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tified hazard ratio for disease progression:                           0.29 (95% CI: 0.13–0.63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8465479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B5984CD-ECFD-43C1-9FE7-D01979DC94BB}"/>
              </a:ext>
            </a:extLst>
          </p:cNvPr>
          <p:cNvSpPr txBox="1"/>
          <p:nvPr/>
        </p:nvSpPr>
        <p:spPr>
          <a:xfrm>
            <a:off x="8651660" y="2526910"/>
            <a:ext cx="102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009</a:t>
            </a:r>
          </a:p>
        </p:txBody>
      </p:sp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E9321FE7-5C7A-4268-B021-2FF99F8B6F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1939872"/>
              </p:ext>
            </p:extLst>
          </p:nvPr>
        </p:nvGraphicFramePr>
        <p:xfrm>
          <a:off x="1299031" y="5365504"/>
          <a:ext cx="8587921" cy="93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18489">
                  <a:extLst>
                    <a:ext uri="{9D8B030D-6E8A-4147-A177-3AD203B41FA5}">
                      <a16:colId xmlns:a16="http://schemas.microsoft.com/office/drawing/2014/main" val="932176634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3372748298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178135971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681606224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2748094594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3192788086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3845579141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600356116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216462170"/>
                    </a:ext>
                  </a:extLst>
                </a:gridCol>
              </a:tblGrid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at risk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3142808"/>
                  </a:ext>
                </a:extLst>
              </a:tr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ESAT-6 high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945776"/>
                  </a:ext>
                </a:extLst>
              </a:tr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ESAT-6 low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0658276"/>
                  </a:ext>
                </a:extLst>
              </a:tr>
            </a:tbl>
          </a:graphicData>
        </a:graphic>
      </p:graphicFrame>
      <p:sp>
        <p:nvSpPr>
          <p:cNvPr id="23" name="テキスト ボックス 22"/>
          <p:cNvSpPr txBox="1"/>
          <p:nvPr/>
        </p:nvSpPr>
        <p:spPr>
          <a:xfrm rot="-5400000">
            <a:off x="648000" y="2952000"/>
            <a:ext cx="4383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s Who Survived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657850" y="5508000"/>
            <a:ext cx="1920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図 24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171437" y="843206"/>
            <a:ext cx="504000" cy="237765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177F4D4-22E3-4E47-A76F-6E430F78900D}"/>
              </a:ext>
            </a:extLst>
          </p:cNvPr>
          <p:cNvSpPr txBox="1"/>
          <p:nvPr/>
        </p:nvSpPr>
        <p:spPr>
          <a:xfrm>
            <a:off x="168297" y="180025"/>
            <a:ext cx="2711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6011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3366" b="5905"/>
          <a:stretch/>
        </p:blipFill>
        <p:spPr>
          <a:xfrm>
            <a:off x="2697479" y="966444"/>
            <a:ext cx="7042341" cy="4634256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77F4D4-22E3-4E47-A76F-6E430F78900D}"/>
              </a:ext>
            </a:extLst>
          </p:cNvPr>
          <p:cNvSpPr txBox="1"/>
          <p:nvPr/>
        </p:nvSpPr>
        <p:spPr>
          <a:xfrm>
            <a:off x="168297" y="180025"/>
            <a:ext cx="2711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-5400000">
            <a:off x="407970" y="3056130"/>
            <a:ext cx="4383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A spot count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417820" y="5612130"/>
            <a:ext cx="1920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24667ED-8464-45C9-879F-01C673D9B2C5}"/>
              </a:ext>
            </a:extLst>
          </p:cNvPr>
          <p:cNvSpPr txBox="1"/>
          <p:nvPr/>
        </p:nvSpPr>
        <p:spPr>
          <a:xfrm>
            <a:off x="8651660" y="2526910"/>
            <a:ext cx="102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057</a:t>
            </a:r>
          </a:p>
        </p:txBody>
      </p:sp>
    </p:spTree>
    <p:extLst>
      <p:ext uri="{BB962C8B-B14F-4D97-AF65-F5344CB8AC3E}">
        <p14:creationId xmlns:p14="http://schemas.microsoft.com/office/powerpoint/2010/main" val="25196260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3872" b="6137"/>
          <a:stretch/>
        </p:blipFill>
        <p:spPr>
          <a:xfrm>
            <a:off x="2880000" y="972000"/>
            <a:ext cx="7106166" cy="4622826"/>
          </a:xfrm>
          <a:prstGeom prst="rect">
            <a:avLst/>
          </a:prstGeom>
        </p:spPr>
      </p:pic>
      <p:graphicFrame>
        <p:nvGraphicFramePr>
          <p:cNvPr id="4" name="表 5">
            <a:extLst>
              <a:ext uri="{FF2B5EF4-FFF2-40B4-BE49-F238E27FC236}">
                <a16:creationId xmlns:a16="http://schemas.microsoft.com/office/drawing/2014/main" id="{03A0E18D-4D52-4163-9831-3E94D9C4AC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2970925"/>
              </p:ext>
            </p:extLst>
          </p:nvPr>
        </p:nvGraphicFramePr>
        <p:xfrm>
          <a:off x="5657850" y="363600"/>
          <a:ext cx="4789866" cy="1432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81354">
                  <a:extLst>
                    <a:ext uri="{9D8B030D-6E8A-4147-A177-3AD203B41FA5}">
                      <a16:colId xmlns:a16="http://schemas.microsoft.com/office/drawing/2014/main" val="2181377161"/>
                    </a:ext>
                  </a:extLst>
                </a:gridCol>
                <a:gridCol w="3008512">
                  <a:extLst>
                    <a:ext uri="{9D8B030D-6E8A-4147-A177-3AD203B41FA5}">
                      <a16:colId xmlns:a16="http://schemas.microsoft.com/office/drawing/2014/main" val="3139930827"/>
                    </a:ext>
                  </a:extLst>
                </a:gridCol>
              </a:tblGrid>
              <a:tr h="277714">
                <a:tc gridSpan="2"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        </a:t>
                      </a:r>
                      <a:r>
                        <a:rPr kumimoji="1" lang="en-US" altLang="ja-JP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verall survival time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9936045"/>
                  </a:ext>
                </a:extLst>
              </a:tr>
              <a:tr h="277714"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CFP-10 high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9 days (95% CI: 862–NA)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4604076"/>
                  </a:ext>
                </a:extLst>
              </a:tr>
              <a:tr h="277714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CFP-10 low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 days (95% CI: 142</a:t>
                      </a:r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529</a:t>
                      </a:r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2510744"/>
                  </a:ext>
                </a:extLst>
              </a:tr>
              <a:tr h="462857">
                <a:tc gridSpan="2"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tified hazard ratio for disease progression:                           0.39 (95% CI: 0.19–0.81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8465479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DD402A8-EC9B-4920-980E-8D0B37E427EF}"/>
              </a:ext>
            </a:extLst>
          </p:cNvPr>
          <p:cNvSpPr txBox="1"/>
          <p:nvPr/>
        </p:nvSpPr>
        <p:spPr>
          <a:xfrm>
            <a:off x="8651660" y="2526910"/>
            <a:ext cx="102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094</a:t>
            </a:r>
          </a:p>
        </p:txBody>
      </p:sp>
      <p:sp>
        <p:nvSpPr>
          <p:cNvPr id="8" name="テキスト ボックス 7"/>
          <p:cNvSpPr txBox="1"/>
          <p:nvPr/>
        </p:nvSpPr>
        <p:spPr>
          <a:xfrm rot="-5400000">
            <a:off x="648000" y="2952000"/>
            <a:ext cx="4383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s Who Survived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657850" y="5508000"/>
            <a:ext cx="1920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171436" y="842400"/>
            <a:ext cx="504000" cy="237765"/>
          </a:xfrm>
          <a:prstGeom prst="rect">
            <a:avLst/>
          </a:prstGeom>
        </p:spPr>
      </p:pic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E9321FE7-5C7A-4268-B021-2FF99F8B6F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6982053"/>
              </p:ext>
            </p:extLst>
          </p:nvPr>
        </p:nvGraphicFramePr>
        <p:xfrm>
          <a:off x="1299031" y="5365504"/>
          <a:ext cx="8587921" cy="93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18489">
                  <a:extLst>
                    <a:ext uri="{9D8B030D-6E8A-4147-A177-3AD203B41FA5}">
                      <a16:colId xmlns:a16="http://schemas.microsoft.com/office/drawing/2014/main" val="932176634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3372748298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178135971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681606224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2748094594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3192788086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3845579141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600356116"/>
                    </a:ext>
                  </a:extLst>
                </a:gridCol>
                <a:gridCol w="858679">
                  <a:extLst>
                    <a:ext uri="{9D8B030D-6E8A-4147-A177-3AD203B41FA5}">
                      <a16:colId xmlns:a16="http://schemas.microsoft.com/office/drawing/2014/main" val="216462170"/>
                    </a:ext>
                  </a:extLst>
                </a:gridCol>
              </a:tblGrid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at risk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3142808"/>
                  </a:ext>
                </a:extLst>
              </a:tr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CFP-10 high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945776"/>
                  </a:ext>
                </a:extLst>
              </a:tr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/CFP-10 low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0658276"/>
                  </a:ext>
                </a:extLst>
              </a:tr>
            </a:tbl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177F4D4-22E3-4E47-A76F-6E430F78900D}"/>
              </a:ext>
            </a:extLst>
          </p:cNvPr>
          <p:cNvSpPr txBox="1"/>
          <p:nvPr/>
        </p:nvSpPr>
        <p:spPr>
          <a:xfrm>
            <a:off x="168297" y="180025"/>
            <a:ext cx="2711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43091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3052" b="5673"/>
          <a:stretch/>
        </p:blipFill>
        <p:spPr>
          <a:xfrm>
            <a:off x="2674619" y="966444"/>
            <a:ext cx="7065201" cy="464568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177F4D4-22E3-4E47-A76F-6E430F78900D}"/>
              </a:ext>
            </a:extLst>
          </p:cNvPr>
          <p:cNvSpPr txBox="1"/>
          <p:nvPr/>
        </p:nvSpPr>
        <p:spPr>
          <a:xfrm>
            <a:off x="168297" y="180025"/>
            <a:ext cx="2711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 rot="-5400000">
            <a:off x="407970" y="3056130"/>
            <a:ext cx="4383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A spot count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417820" y="5612130"/>
            <a:ext cx="1920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24667ED-8464-45C9-879F-01C673D9B2C5}"/>
              </a:ext>
            </a:extLst>
          </p:cNvPr>
          <p:cNvSpPr txBox="1"/>
          <p:nvPr/>
        </p:nvSpPr>
        <p:spPr>
          <a:xfrm>
            <a:off x="8651660" y="2526910"/>
            <a:ext cx="102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024</a:t>
            </a:r>
          </a:p>
        </p:txBody>
      </p:sp>
    </p:spTree>
    <p:extLst>
      <p:ext uri="{BB962C8B-B14F-4D97-AF65-F5344CB8AC3E}">
        <p14:creationId xmlns:p14="http://schemas.microsoft.com/office/powerpoint/2010/main" val="39384398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3563" b="6137"/>
          <a:stretch/>
        </p:blipFill>
        <p:spPr>
          <a:xfrm>
            <a:off x="2880000" y="972000"/>
            <a:ext cx="7129026" cy="4622826"/>
          </a:xfrm>
          <a:prstGeom prst="rect">
            <a:avLst/>
          </a:prstGeom>
        </p:spPr>
      </p:pic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CEE9FE8E-D51A-42AA-B652-5C469C0491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8837544"/>
              </p:ext>
            </p:extLst>
          </p:nvPr>
        </p:nvGraphicFramePr>
        <p:xfrm>
          <a:off x="5659200" y="363600"/>
          <a:ext cx="5366181" cy="1432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95686">
                  <a:extLst>
                    <a:ext uri="{9D8B030D-6E8A-4147-A177-3AD203B41FA5}">
                      <a16:colId xmlns:a16="http://schemas.microsoft.com/office/drawing/2014/main" val="2181377161"/>
                    </a:ext>
                  </a:extLst>
                </a:gridCol>
                <a:gridCol w="3370495">
                  <a:extLst>
                    <a:ext uri="{9D8B030D-6E8A-4147-A177-3AD203B41FA5}">
                      <a16:colId xmlns:a16="http://schemas.microsoft.com/office/drawing/2014/main" val="3139930827"/>
                    </a:ext>
                  </a:extLst>
                </a:gridCol>
              </a:tblGrid>
              <a:tr h="277714">
                <a:tc gridSpan="2"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        </a:t>
                      </a:r>
                      <a:r>
                        <a:rPr kumimoji="1" lang="en-US" altLang="ja-JP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verall survival time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9936045"/>
                  </a:ext>
                </a:extLst>
              </a:tr>
              <a:tr h="277714"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 high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9 days (95% CI: 862–NA)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4604076"/>
                  </a:ext>
                </a:extLst>
              </a:tr>
              <a:tr h="277714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 low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 days (95% CI: 135–NA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2510744"/>
                  </a:ext>
                </a:extLst>
              </a:tr>
              <a:tr h="462857">
                <a:tc gridSpan="2"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tified hazard ratio for disease progression:                           0.32 (95% CI: 0.14–0.76)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8465479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24667ED-8464-45C9-879F-01C673D9B2C5}"/>
              </a:ext>
            </a:extLst>
          </p:cNvPr>
          <p:cNvSpPr txBox="1"/>
          <p:nvPr/>
        </p:nvSpPr>
        <p:spPr>
          <a:xfrm>
            <a:off x="8651660" y="2526910"/>
            <a:ext cx="102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067</a:t>
            </a: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4B29E947-7122-4A37-A05A-681400B174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3361004"/>
              </p:ext>
            </p:extLst>
          </p:nvPr>
        </p:nvGraphicFramePr>
        <p:xfrm>
          <a:off x="1440000" y="5364000"/>
          <a:ext cx="8460000" cy="93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60176">
                  <a:extLst>
                    <a:ext uri="{9D8B030D-6E8A-4147-A177-3AD203B41FA5}">
                      <a16:colId xmlns:a16="http://schemas.microsoft.com/office/drawing/2014/main" val="932176634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3372748298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681606224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2748094594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3192788086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3845579141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1652633073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2568160488"/>
                    </a:ext>
                  </a:extLst>
                </a:gridCol>
                <a:gridCol w="862478">
                  <a:extLst>
                    <a:ext uri="{9D8B030D-6E8A-4147-A177-3AD203B41FA5}">
                      <a16:colId xmlns:a16="http://schemas.microsoft.com/office/drawing/2014/main" val="216462170"/>
                    </a:ext>
                  </a:extLst>
                </a:gridCol>
              </a:tblGrid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at risk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3142808"/>
                  </a:ext>
                </a:extLst>
              </a:tr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 high</a:t>
                      </a:r>
                      <a:endParaRPr kumimoji="1" lang="ja-JP" alt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945776"/>
                  </a:ext>
                </a:extLst>
              </a:tr>
              <a:tr h="31200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 low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0658276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177F4D4-22E3-4E47-A76F-6E430F78900D}"/>
              </a:ext>
            </a:extLst>
          </p:cNvPr>
          <p:cNvSpPr txBox="1"/>
          <p:nvPr/>
        </p:nvSpPr>
        <p:spPr>
          <a:xfrm>
            <a:off x="168297" y="180025"/>
            <a:ext cx="2711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173200" y="842400"/>
            <a:ext cx="504000" cy="237765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 rot="-5400000">
            <a:off x="648000" y="2952000"/>
            <a:ext cx="4383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s Who Survive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657850" y="5508000"/>
            <a:ext cx="1920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68419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4255" b="5673"/>
          <a:stretch/>
        </p:blipFill>
        <p:spPr>
          <a:xfrm>
            <a:off x="2731769" y="966444"/>
            <a:ext cx="7041393" cy="464568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177F4D4-22E3-4E47-A76F-6E430F78900D}"/>
              </a:ext>
            </a:extLst>
          </p:cNvPr>
          <p:cNvSpPr txBox="1"/>
          <p:nvPr/>
        </p:nvSpPr>
        <p:spPr>
          <a:xfrm>
            <a:off x="168297" y="180025"/>
            <a:ext cx="2711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-5400000">
            <a:off x="407970" y="3056130"/>
            <a:ext cx="4383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A spot count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417820" y="5612130"/>
            <a:ext cx="1920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24667ED-8464-45C9-879F-01C673D9B2C5}"/>
              </a:ext>
            </a:extLst>
          </p:cNvPr>
          <p:cNvSpPr txBox="1"/>
          <p:nvPr/>
        </p:nvSpPr>
        <p:spPr>
          <a:xfrm>
            <a:off x="8651660" y="2526910"/>
            <a:ext cx="102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477</a:t>
            </a:r>
          </a:p>
        </p:txBody>
      </p:sp>
    </p:spTree>
    <p:extLst>
      <p:ext uri="{BB962C8B-B14F-4D97-AF65-F5344CB8AC3E}">
        <p14:creationId xmlns:p14="http://schemas.microsoft.com/office/powerpoint/2010/main" val="1070928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275</Words>
  <Application>Microsoft Macintosh PowerPoint</Application>
  <PresentationFormat>Widescreen</PresentationFormat>
  <Paragraphs>9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游ゴシック</vt:lpstr>
      <vt:lpstr>游ゴシック Light</vt:lpstr>
      <vt:lpstr>Arial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呼吸器病学</dc:creator>
  <cp:lastModifiedBy>小林　信明</cp:lastModifiedBy>
  <cp:revision>29</cp:revision>
  <dcterms:created xsi:type="dcterms:W3CDTF">2021-03-05T14:48:58Z</dcterms:created>
  <dcterms:modified xsi:type="dcterms:W3CDTF">2021-04-11T01:55:44Z</dcterms:modified>
</cp:coreProperties>
</file>